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20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53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4427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677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193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35683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3186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59630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7885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2061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834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77774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400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DE8975-750A-426D-9631-D5B08EF73B6E}" type="datetimeFigureOut">
              <a:rPr lang="ko-KR" altLang="en-US" smtClean="0"/>
              <a:t>2021-05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30DD2B-1631-4503-812C-AC19206AC1C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257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" y="211014"/>
            <a:ext cx="67759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 1. Top 50 hypoxia regulated genes in RCC4-VHL cells treated under hypoxia 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136687A-B27B-403F-BB8B-142B2F2463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1819044"/>
              </p:ext>
            </p:extLst>
          </p:nvPr>
        </p:nvGraphicFramePr>
        <p:xfrm>
          <a:off x="187568" y="926123"/>
          <a:ext cx="6447693" cy="73251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73953">
                  <a:extLst>
                    <a:ext uri="{9D8B030D-6E8A-4147-A177-3AD203B41FA5}">
                      <a16:colId xmlns:a16="http://schemas.microsoft.com/office/drawing/2014/main" val="999665456"/>
                    </a:ext>
                  </a:extLst>
                </a:gridCol>
                <a:gridCol w="4040816">
                  <a:extLst>
                    <a:ext uri="{9D8B030D-6E8A-4147-A177-3AD203B41FA5}">
                      <a16:colId xmlns:a16="http://schemas.microsoft.com/office/drawing/2014/main" val="3209362313"/>
                    </a:ext>
                  </a:extLst>
                </a:gridCol>
                <a:gridCol w="812076">
                  <a:extLst>
                    <a:ext uri="{9D8B030D-6E8A-4147-A177-3AD203B41FA5}">
                      <a16:colId xmlns:a16="http://schemas.microsoft.com/office/drawing/2014/main" val="669746909"/>
                    </a:ext>
                  </a:extLst>
                </a:gridCol>
                <a:gridCol w="635964">
                  <a:extLst>
                    <a:ext uri="{9D8B030D-6E8A-4147-A177-3AD203B41FA5}">
                      <a16:colId xmlns:a16="http://schemas.microsoft.com/office/drawing/2014/main" val="2812449891"/>
                    </a:ext>
                  </a:extLst>
                </a:gridCol>
                <a:gridCol w="684884">
                  <a:extLst>
                    <a:ext uri="{9D8B030D-6E8A-4147-A177-3AD203B41FA5}">
                      <a16:colId xmlns:a16="http://schemas.microsoft.com/office/drawing/2014/main" val="438840339"/>
                    </a:ext>
                  </a:extLst>
                </a:gridCol>
              </a:tblGrid>
              <a:tr h="144303"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800" u="none" strike="noStrike">
                          <a:effectLst/>
                        </a:rPr>
                        <a:t>　</a:t>
                      </a:r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AM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lternate NAME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old Chang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 valu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3899064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ngiopoietin-like 4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NGPTL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52.406238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u="none" strike="noStrike">
                          <a:effectLst/>
                        </a:rPr>
                        <a:t>1.31194E-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7048805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drenomedullin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DM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38.989128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39733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717030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N-myc downstream regulated gene 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DRG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34.993134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36485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9979914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Enolase 2 (gamma, neuronal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NO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24.482291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721580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5459575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Lysyl oxidas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OX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8.8435646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1243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7839808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olute carrier family 2 (facilitated glucose transporter), member 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SLC2A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6.522193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0428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8062602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erpin peptidase inhibitor, clade E (nexin, plasminogen activator inhibitor type 1), member 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ERPINE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5.752402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8976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2717296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sv-SE" sz="800" u="none" strike="noStrike">
                          <a:effectLst/>
                        </a:rPr>
                        <a:t>Interleukin 6 (interferon, beta 2) </a:t>
                      </a:r>
                      <a:endParaRPr lang="sv-SE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IL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5.605687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26014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394165"/>
                  </a:ext>
                </a:extLst>
              </a:tr>
              <a:tr h="2494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rotein tyrosine phosphatase, receptor type, f polypeptide (PTPRF), interacting protein (liprin), alpha 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PFIA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5.05147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130832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546660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Transmembrane protein 45A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MEM45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4.2873521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29942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32356008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V-maf musculoaponeurotic fibrosarcoma oncogene homolog F (avian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AFF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3.9642546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108508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1998347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arbonic anhydrase IX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A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3.549490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919815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3292560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ibosomal Modification Protein RimK Like Family Member 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IMKL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1.9449866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2929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953770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Dual specificity phosphatase 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USP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1.876188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9652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1195644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 Zinc finger protein 114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ZNF11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1.865217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273982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73933029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nsulin induced gene 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INSIG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1.471641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93406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026405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olypeptide N-acetylgalactosaminyltransferase 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ALNT1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999250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47225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253979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 Tribbles homolog 3 (Drosophila)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RIB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78285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2153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313912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nsulin-like growth factor binding protein 3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IGFB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641773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214238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6741120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hemokine (C-X-C motif) ligand 1 (melanoma growth stimulating activity, alpha)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XCL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607406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9037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750024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amily With Sequence Similarity 162 Member 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M162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585371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800" u="none" strike="noStrike">
                          <a:effectLst/>
                        </a:rPr>
                        <a:t>8.55293E-0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92557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rocollagen-proline, 2-oxoglutarate 4-dioxygenase (proline 4-hydroxylase), alpha polypeptide II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4HA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4589539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24518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1557602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pt-BR" sz="800" u="none" strike="noStrike">
                          <a:effectLst/>
                        </a:rPr>
                        <a:t>BCL2/adenovirus E1B 19kDa interacting protein 3 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NIP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112024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6153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055063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 kinase (PRKA) anchor protein (gravin) 12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KAP1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10.0980162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28845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4824076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 Sperm associated antigen 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PAG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6710106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4532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1819597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 Hypoxia Inducible Lipid Droplet-Associated/Hypoxia-inducible protein 2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HILPD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5356635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52343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692967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amily with sequence similarity 57, member A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M57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4501244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25969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1085459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Fatty acid binding protein 6, ileal (gastrotropin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FABP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4217823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4468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2853340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2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Insulin receptor substrate 2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IRS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2920698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528038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4707443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Dehydrogenase/Reductase SDR family member 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HRS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2470936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0493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5990326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hosphoglycerate kinase 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GK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17897674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206911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9806247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Adipose differentiation-related protein/Perilipin-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LIN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9.11557291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617647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0031862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BCL2/adenovirus E1B 19kDa interacting protein 3-like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NIP3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8.3609487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3469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9353558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DNA-damage-inducible transcript 4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DIT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8.3358732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539463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3546791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V-ets erythroblastosis virus E26 oncogene homolog 1 (avian)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T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7.9778500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86438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6913736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ynaptotagmin-like 2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YTL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7.80825408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123512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132675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exokinase 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HK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7.76507575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211209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5669691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rotein phosphatase 1, regulatory (inhibitor) subunit 3C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PP1R3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7.6413806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9628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7718995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olute carrier organic anion transporter family, member 4A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LCO4A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7.2954653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3066525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8164480"/>
                  </a:ext>
                </a:extLst>
              </a:tr>
              <a:tr h="2494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ema domain, seven thrombospondin repeats (type 1 and type 1-like), transmembrane domain (TM) and short cytoplasmic domain, (semaphorin) 5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EMA5B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96601381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1965238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1107606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Stanniocalcin 2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STC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8796412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0375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60331134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Hexokinase 2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HK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8321200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061809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1804648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Lactate dehydrogenase 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DH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80219328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43730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4286681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Endothelin 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EDN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5507798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9197715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16965182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Prostate and breast cancer overexpressed 1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BOV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54775345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90438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3462599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Transglutaminase 2 (C polypeptide, protein-glutamine-gamma-glutamyltransferase)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M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5130501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51848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7679057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D44 molecule (Indian blood group)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4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47105078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121738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1169841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RAB42, member RAS homolog family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B4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3364142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33548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5976700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4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Glycogen synthase 1 (muscle) 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YS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2752227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0.0018136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23818"/>
                  </a:ext>
                </a:extLst>
              </a:tr>
              <a:tr h="13949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effectLst/>
                        </a:rPr>
                        <a:t>5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effectLst/>
                        </a:rPr>
                        <a:t>CUB domain containing protein 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DCP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>
                          <a:effectLst/>
                        </a:rPr>
                        <a:t>6.27522273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altLang="ko-KR" sz="800" u="none" strike="noStrike" dirty="0">
                          <a:effectLst/>
                        </a:rPr>
                        <a:t>0.0045910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3790" marR="3790" marT="379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434074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07051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1</TotalTime>
  <Words>568</Words>
  <Application>Microsoft Office PowerPoint</Application>
  <PresentationFormat>On-screen Show (4:3)</PresentationFormat>
  <Paragraphs>25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jung Moon</dc:creator>
  <cp:lastModifiedBy>Moon Ejung</cp:lastModifiedBy>
  <cp:revision>22</cp:revision>
  <cp:lastPrinted>2018-12-27T23:59:30Z</cp:lastPrinted>
  <dcterms:created xsi:type="dcterms:W3CDTF">2018-12-27T23:58:40Z</dcterms:created>
  <dcterms:modified xsi:type="dcterms:W3CDTF">2021-05-20T15:22:49Z</dcterms:modified>
</cp:coreProperties>
</file>